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64" y="-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圆角矩形 3"/>
          <p:cNvSpPr/>
          <p:nvPr/>
        </p:nvSpPr>
        <p:spPr>
          <a:xfrm>
            <a:off x="3347864" y="1124744"/>
            <a:ext cx="2088232" cy="72008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Debridement</a:t>
            </a:r>
          </a:p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N=187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782469" y="470096"/>
            <a:ext cx="31470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Patients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with osteomyelitis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 flipH="1">
            <a:off x="4355976" y="836712"/>
            <a:ext cx="1" cy="248917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圆角矩形 7"/>
          <p:cNvSpPr/>
          <p:nvPr/>
        </p:nvSpPr>
        <p:spPr>
          <a:xfrm>
            <a:off x="3311860" y="2327987"/>
            <a:ext cx="2088232" cy="1512168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Skeletal Stabilization</a:t>
            </a:r>
          </a:p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&amp; Antibiotic Therapy </a:t>
            </a:r>
          </a:p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N=168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圆角矩形 8"/>
          <p:cNvSpPr/>
          <p:nvPr/>
        </p:nvSpPr>
        <p:spPr>
          <a:xfrm>
            <a:off x="3380837" y="4941168"/>
            <a:ext cx="2088232" cy="108012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one grafting</a:t>
            </a:r>
          </a:p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&amp;  Fixation </a:t>
            </a:r>
          </a:p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N=125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直接箭头连接符 9"/>
          <p:cNvCxnSpPr/>
          <p:nvPr/>
        </p:nvCxnSpPr>
        <p:spPr>
          <a:xfrm flipH="1">
            <a:off x="4355976" y="1916832"/>
            <a:ext cx="2" cy="37204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 flipH="1">
            <a:off x="2051720" y="2060848"/>
            <a:ext cx="223224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矩形 13"/>
          <p:cNvSpPr/>
          <p:nvPr/>
        </p:nvSpPr>
        <p:spPr>
          <a:xfrm>
            <a:off x="611560" y="1556792"/>
            <a:ext cx="1440160" cy="100811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Bone defect &gt; 4cm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N=19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直接箭头连接符 14"/>
          <p:cNvCxnSpPr/>
          <p:nvPr/>
        </p:nvCxnSpPr>
        <p:spPr>
          <a:xfrm flipH="1">
            <a:off x="4391982" y="3912163"/>
            <a:ext cx="1" cy="92985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5905820" y="3501008"/>
            <a:ext cx="2458940" cy="764941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Persistent infection and chose other hospitals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N=22 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67544" y="3537012"/>
            <a:ext cx="2458940" cy="136815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Persistent infection and underwent 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second 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debridement, where bone defect &gt; 4cm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N=17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905820" y="4307622"/>
            <a:ext cx="2458940" cy="56153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Others 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N=4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直接箭头连接符 21"/>
          <p:cNvCxnSpPr/>
          <p:nvPr/>
        </p:nvCxnSpPr>
        <p:spPr>
          <a:xfrm flipH="1">
            <a:off x="2926484" y="4221088"/>
            <a:ext cx="1429494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4424953" y="3991666"/>
            <a:ext cx="1429494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>
            <a:off x="4427984" y="4523646"/>
            <a:ext cx="1429494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矩形 26"/>
          <p:cNvSpPr/>
          <p:nvPr/>
        </p:nvSpPr>
        <p:spPr>
          <a:xfrm>
            <a:off x="251520" y="44624"/>
            <a:ext cx="8424936" cy="619268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/>
          <p:cNvSpPr/>
          <p:nvPr/>
        </p:nvSpPr>
        <p:spPr>
          <a:xfrm>
            <a:off x="251520" y="6381328"/>
            <a:ext cx="84249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zh-CN" dirty="0"/>
              <a:t>Figure S1.  The flow chart of selection of patients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1088008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54</Words>
  <Application>Microsoft Office PowerPoint</Application>
  <PresentationFormat>全屏显示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jw</dc:creator>
  <cp:lastModifiedBy>deng</cp:lastModifiedBy>
  <cp:revision>7</cp:revision>
  <dcterms:created xsi:type="dcterms:W3CDTF">2017-10-16T13:43:19Z</dcterms:created>
  <dcterms:modified xsi:type="dcterms:W3CDTF">2017-11-04T13:15:57Z</dcterms:modified>
</cp:coreProperties>
</file>